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140" d="100"/>
          <a:sy n="140" d="100"/>
        </p:scale>
        <p:origin x="1734" y="-357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E6390E-221F-44D2-B739-E8CBDAD162C1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91AEC0-73F6-4058-A786-15460E4999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222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DC3413-77C0-49D1-B643-B8B832E8EEBA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1154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4291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3348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6719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7672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4079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8015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6102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339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6840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3585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4960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DF4067-635E-459B-9BB0-5664D3E11DAE}" type="datetimeFigureOut">
              <a:rPr lang="de-DE" smtClean="0"/>
              <a:t>26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9C910E-4359-40B6-8394-04AB0B7062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683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Grafik 30">
            <a:extLst>
              <a:ext uri="{FF2B5EF4-FFF2-40B4-BE49-F238E27FC236}">
                <a16:creationId xmlns:a16="http://schemas.microsoft.com/office/drawing/2014/main" id="{340D97EF-C636-6361-97E3-24DF1DBCB3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2875" y="4690683"/>
            <a:ext cx="2169642" cy="1093500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A521E3C5-149A-4FEC-FAEA-9BD57E4D73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2517" y="4690683"/>
            <a:ext cx="2169642" cy="1093500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id="{4C6F34B2-3813-8520-985C-97072004B9DC}"/>
              </a:ext>
            </a:extLst>
          </p:cNvPr>
          <p:cNvSpPr txBox="1"/>
          <p:nvPr/>
        </p:nvSpPr>
        <p:spPr>
          <a:xfrm>
            <a:off x="996201" y="432698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FeS</a:t>
            </a:r>
            <a:endParaRPr lang="de-DE" sz="900" dirty="0"/>
          </a:p>
          <a:p>
            <a:r>
              <a:rPr lang="de-DE" sz="900" dirty="0" err="1"/>
              <a:t>cluster</a:t>
            </a:r>
            <a:endParaRPr lang="de-DE" sz="900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1A90F35-5AA8-AC9B-C015-BB7FA32745AF}"/>
              </a:ext>
            </a:extLst>
          </p:cNvPr>
          <p:cNvSpPr txBox="1"/>
          <p:nvPr/>
        </p:nvSpPr>
        <p:spPr>
          <a:xfrm>
            <a:off x="979707" y="3716018"/>
            <a:ext cx="646612" cy="663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mono/</a:t>
            </a:r>
          </a:p>
          <a:p>
            <a:r>
              <a:rPr lang="de-DE" sz="900" dirty="0"/>
              <a:t>multiple</a:t>
            </a:r>
          </a:p>
          <a:p>
            <a:r>
              <a:rPr lang="de-DE" sz="900" dirty="0" err="1"/>
              <a:t>Fe</a:t>
            </a:r>
            <a:endParaRPr lang="de-DE" sz="900" dirty="0"/>
          </a:p>
          <a:p>
            <a:endParaRPr lang="de-DE" sz="1013" dirty="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78EF822F-7FA3-C8DA-1B72-6DE73F21EEB1}"/>
              </a:ext>
            </a:extLst>
          </p:cNvPr>
          <p:cNvSpPr txBox="1"/>
          <p:nvPr/>
        </p:nvSpPr>
        <p:spPr>
          <a:xfrm>
            <a:off x="979707" y="4781026"/>
            <a:ext cx="646612" cy="386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heme</a:t>
            </a:r>
            <a:endParaRPr lang="de-DE" sz="900" dirty="0"/>
          </a:p>
          <a:p>
            <a:endParaRPr lang="de-DE" sz="1013" dirty="0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06BC803E-5A3E-5F2A-AA91-24B3AD4FC5F6}"/>
              </a:ext>
            </a:extLst>
          </p:cNvPr>
          <p:cNvSpPr txBox="1"/>
          <p:nvPr/>
        </p:nvSpPr>
        <p:spPr>
          <a:xfrm>
            <a:off x="1829164" y="6159005"/>
            <a:ext cx="3646706" cy="18582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75" b="1" dirty="0">
                <a:latin typeface="Arial" panose="020B0604020202020204" pitchFamily="34" charset="0"/>
                <a:ea typeface="Calibri" panose="020F0502020204030204" pitchFamily="34" charset="0"/>
              </a:rPr>
              <a:t>Fig. S6 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Quantitative analyses of the immunoblots on iron containing chloroplast proteins of </a:t>
            </a:r>
            <a:r>
              <a:rPr lang="en-US" sz="675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the wild type (WT) and the </a:t>
            </a:r>
            <a:r>
              <a:rPr lang="en-US" sz="675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WHIRLY1</a:t>
            </a:r>
            <a:r>
              <a:rPr lang="en-US" sz="675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knockdown lines W1-1 and W1-7 as 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shown in Fig. 6.</a:t>
            </a:r>
            <a:r>
              <a:rPr lang="en-US" sz="675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Immunoblots were performed with total leaf extracts from plants grown for 10 days in continuous light of four different irradiances (50, 100, 200 and 350 µmol m</a:t>
            </a:r>
            <a:r>
              <a:rPr lang="en-US" sz="675" baseline="30000" dirty="0">
                <a:latin typeface="Arial" panose="020B0604020202020204" pitchFamily="34" charset="0"/>
                <a:ea typeface="Calibri" panose="020F0502020204030204" pitchFamily="34" charset="0"/>
              </a:rPr>
              <a:t>-2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 s</a:t>
            </a:r>
            <a:r>
              <a:rPr lang="en-US" sz="675" baseline="30000" dirty="0">
                <a:latin typeface="Arial" panose="020B0604020202020204" pitchFamily="34" charset="0"/>
                <a:ea typeface="Calibri" panose="020F0502020204030204" pitchFamily="34" charset="0"/>
              </a:rPr>
              <a:t>-1 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). Results for the different light intensities </a:t>
            </a:r>
            <a:r>
              <a:rPr lang="en-US" sz="675">
                <a:latin typeface="Arial" panose="020B0604020202020204" pitchFamily="34" charset="0"/>
                <a:ea typeface="Calibri" panose="020F0502020204030204" pitchFamily="34" charset="0"/>
              </a:rPr>
              <a:t>are shown as </a:t>
            </a:r>
            <a:r>
              <a:rPr lang="en-US" sz="675" dirty="0">
                <a:latin typeface="Arial" panose="020B0604020202020204" pitchFamily="34" charset="0"/>
                <a:ea typeface="Calibri" panose="020F0502020204030204" pitchFamily="34" charset="0"/>
              </a:rPr>
              <a:t>columns of different gray scale.</a:t>
            </a:r>
            <a:endParaRPr lang="en-US" sz="675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Except for </a:t>
            </a:r>
            <a:r>
              <a:rPr lang="en-US" sz="675" dirty="0" err="1">
                <a:latin typeface="Arial" panose="020B0604020202020204" pitchFamily="34" charset="0"/>
                <a:ea typeface="Times New Roman" panose="02020603050405020304" pitchFamily="18" charset="0"/>
              </a:rPr>
              <a:t>PsaA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, detection of immunoreactive complexes was done using a </a:t>
            </a:r>
            <a:r>
              <a:rPr lang="en-US" sz="675" dirty="0" err="1">
                <a:latin typeface="Arial" panose="020B0604020202020204" pitchFamily="34" charset="0"/>
                <a:ea typeface="Times New Roman" panose="02020603050405020304" pitchFamily="18" charset="0"/>
              </a:rPr>
              <a:t>ChemiDoc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 system allowing to calculate signal densities using the Image-Lab 6.1. software. The </a:t>
            </a:r>
            <a:r>
              <a:rPr lang="en-US" sz="675" dirty="0" err="1">
                <a:latin typeface="Arial" panose="020B0604020202020204" pitchFamily="34" charset="0"/>
                <a:ea typeface="Times New Roman" panose="02020603050405020304" pitchFamily="18" charset="0"/>
              </a:rPr>
              <a:t>PsaA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 immunoblot visualized by a film was scanned and quantified using ImageJ (Stael et al. 2022).</a:t>
            </a:r>
          </a:p>
          <a:p>
            <a:endParaRPr lang="en-US" sz="675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en-US" sz="675" i="1" dirty="0">
                <a:latin typeface="Arial" panose="020B0604020202020204" pitchFamily="34" charset="0"/>
                <a:ea typeface="Times New Roman" panose="02020603050405020304" pitchFamily="18" charset="0"/>
              </a:rPr>
              <a:t>Reference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: </a:t>
            </a:r>
          </a:p>
          <a:p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Stael S, Miller LP, Fernández-Fernández AD, Van </a:t>
            </a:r>
            <a:r>
              <a:rPr lang="en-US" sz="675" dirty="0" err="1">
                <a:latin typeface="Arial" panose="020B0604020202020204" pitchFamily="34" charset="0"/>
                <a:ea typeface="Times New Roman" panose="02020603050405020304" pitchFamily="18" charset="0"/>
              </a:rPr>
              <a:t>Breusegem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 F (2022) Detection of damage-activated </a:t>
            </a:r>
            <a:r>
              <a:rPr lang="en-US" sz="675" dirty="0" err="1">
                <a:latin typeface="Arial" panose="020B0604020202020204" pitchFamily="34" charset="0"/>
                <a:ea typeface="Times New Roman" panose="02020603050405020304" pitchFamily="18" charset="0"/>
              </a:rPr>
              <a:t>metacaspase</a:t>
            </a:r>
            <a:r>
              <a:rPr lang="en-US" sz="675" dirty="0">
                <a:latin typeface="Arial" panose="020B0604020202020204" pitchFamily="34" charset="0"/>
                <a:ea typeface="Times New Roman" panose="02020603050405020304" pitchFamily="18" charset="0"/>
              </a:rPr>
              <a:t> activity by Western blot in plants. In: Klemencic M, Stael S, Huesgen PF (eds) Plant proteases and plant cell death: methods and protocols, Springer, New York, pp127-137, https://doi.org/10.1007/978-1-0716-2079-3_11</a:t>
            </a:r>
            <a:endParaRPr lang="de-DE" sz="675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675" b="1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endParaRPr lang="en-US" sz="675" b="1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E048845E-03D3-1CA5-AB19-967B03CCB0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2875" y="316683"/>
            <a:ext cx="2169642" cy="10935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3F5077BE-B147-8A27-8B85-757FE3455A1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2517" y="316683"/>
            <a:ext cx="2169642" cy="1093500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97DA9317-67B5-38E2-FEB1-DE25ED84BE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2517" y="1410183"/>
            <a:ext cx="2169642" cy="1093500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787DA224-44F7-3BB8-CE78-CB650B5B929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82875" y="2503683"/>
            <a:ext cx="2169642" cy="1093500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8248400C-2C5C-9B2D-448A-4EC0F088A7C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82875" y="1410183"/>
            <a:ext cx="2169642" cy="10935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B57B9F4A-82D5-100C-38BD-8F4B1296313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52517" y="2503683"/>
            <a:ext cx="2169642" cy="1093500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611A74ED-F250-9048-AB9E-2271F81120D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82875" y="3597183"/>
            <a:ext cx="2169642" cy="1093500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64CBC25F-7507-4E66-893F-4A79A1F7E43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52517" y="3597183"/>
            <a:ext cx="2169642" cy="109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0068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2</Words>
  <Application>Microsoft Office PowerPoint</Application>
  <PresentationFormat>Bildschirmpräsentation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in Krupinska</dc:creator>
  <cp:lastModifiedBy>Karin Krupinska</cp:lastModifiedBy>
  <cp:revision>2</cp:revision>
  <dcterms:created xsi:type="dcterms:W3CDTF">2025-05-26T08:07:19Z</dcterms:created>
  <dcterms:modified xsi:type="dcterms:W3CDTF">2025-05-26T08:14:38Z</dcterms:modified>
</cp:coreProperties>
</file>